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144000" type="screen4x3"/>
  <p:notesSz cx="6805613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162" autoAdjust="0"/>
    <p:restoredTop sz="94660"/>
  </p:normalViewPr>
  <p:slideViewPr>
    <p:cSldViewPr snapToGrid="0">
      <p:cViewPr varScale="1">
        <p:scale>
          <a:sx n="84" d="100"/>
          <a:sy n="84" d="100"/>
        </p:scale>
        <p:origin x="282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4956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15626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32480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7463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32663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79058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4871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72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9591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8139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39625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759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図 15">
            <a:extLst>
              <a:ext uri="{FF2B5EF4-FFF2-40B4-BE49-F238E27FC236}">
                <a16:creationId xmlns:a16="http://schemas.microsoft.com/office/drawing/2014/main" id="{577FC5E1-161A-4DDF-B594-B378E57BC9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0716" y="6679918"/>
            <a:ext cx="2834434" cy="2059534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23275C7D-4FC4-49F1-84E8-967C5BA9F88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90166" y="6679918"/>
            <a:ext cx="2834434" cy="2059534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35992104-59AE-41A3-B244-0692EE84B93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5941" y="2277768"/>
            <a:ext cx="2801718" cy="2035762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DE99A974-3016-425C-89AE-05C44980B17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54916" y="2277768"/>
            <a:ext cx="2801718" cy="2035762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AB8A9BF5-8964-4FBD-9D9E-8B56032D600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5311" y="4533790"/>
            <a:ext cx="2836990" cy="2061391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775F74BB-E193-4202-8C10-EC3E99F6575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44761" y="4533790"/>
            <a:ext cx="2836990" cy="2061391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815CB024-9DD3-4B1C-9AFF-8755197D5C5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25778" y="130998"/>
            <a:ext cx="2817472" cy="2047209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3E38E2A4-B984-40C4-81DA-0EF16D2659D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545228" y="130998"/>
            <a:ext cx="2817472" cy="2047209"/>
          </a:xfrm>
          <a:prstGeom prst="rect">
            <a:avLst/>
          </a:prstGeom>
        </p:spPr>
      </p:pic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3520C718-45A1-408E-9534-F957D2CF8A23}"/>
              </a:ext>
            </a:extLst>
          </p:cNvPr>
          <p:cNvSpPr txBox="1"/>
          <p:nvPr/>
        </p:nvSpPr>
        <p:spPr>
          <a:xfrm>
            <a:off x="721739" y="6779561"/>
            <a:ext cx="269121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655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= indeterminable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CS: 3 knots  (HR: 95%CI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4.3 (1.42: 0.76-2.66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percentile = 7.4 (ref.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10.9 (1.07: 0.60-1.91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BD9E2393-D9C8-4715-9DE1-E81407D0EE7F}"/>
              </a:ext>
            </a:extLst>
          </p:cNvPr>
          <p:cNvSpPr txBox="1"/>
          <p:nvPr/>
        </p:nvSpPr>
        <p:spPr>
          <a:xfrm rot="16200000">
            <a:off x="-342530" y="7486265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766FE9EB-3CF9-4CF8-9062-A376A91BC28C}"/>
              </a:ext>
            </a:extLst>
          </p:cNvPr>
          <p:cNvSpPr txBox="1"/>
          <p:nvPr/>
        </p:nvSpPr>
        <p:spPr>
          <a:xfrm>
            <a:off x="1992841" y="858001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38BA8436-836C-4D21-B3F5-C3C24A68E629}"/>
              </a:ext>
            </a:extLst>
          </p:cNvPr>
          <p:cNvSpPr txBox="1"/>
          <p:nvPr/>
        </p:nvSpPr>
        <p:spPr>
          <a:xfrm rot="16200000">
            <a:off x="2866690" y="7486265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66AB23DB-5436-433C-89A2-D83C101FC91C}"/>
              </a:ext>
            </a:extLst>
          </p:cNvPr>
          <p:cNvSpPr txBox="1"/>
          <p:nvPr/>
        </p:nvSpPr>
        <p:spPr>
          <a:xfrm>
            <a:off x="5202061" y="858001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BF14D9AE-802A-43F3-BFF8-89033B384272}"/>
              </a:ext>
            </a:extLst>
          </p:cNvPr>
          <p:cNvSpPr txBox="1"/>
          <p:nvPr/>
        </p:nvSpPr>
        <p:spPr>
          <a:xfrm>
            <a:off x="4117402" y="6770234"/>
            <a:ext cx="2603161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642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2.3 (3.16: 1.01-9.91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= indeterminable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CS: 3 knots  (HR: 95%CI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4.3 (1.91: 1.02-3.59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percentile = 7.4 (ref.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10.9 (0.87: 0.46-1.64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D7886AF4-48CA-4E1C-8FE4-71F227D2478C}"/>
              </a:ext>
            </a:extLst>
          </p:cNvPr>
          <p:cNvSpPr txBox="1"/>
          <p:nvPr/>
        </p:nvSpPr>
        <p:spPr>
          <a:xfrm>
            <a:off x="1207185" y="4468132"/>
            <a:ext cx="2691217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256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indeterminable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CS: 3 knots  (HR: 95%CI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4.3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1.29: 0.79-2.12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percentile = 7.4 (ref.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10.9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(1.15: 0.80-1.66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9BA79ECF-6EDE-44D7-A201-DD34A822700F}"/>
              </a:ext>
            </a:extLst>
          </p:cNvPr>
          <p:cNvSpPr txBox="1"/>
          <p:nvPr/>
        </p:nvSpPr>
        <p:spPr>
          <a:xfrm rot="16200000">
            <a:off x="-342530" y="5325995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1B9B1E9F-D5C7-445A-B1DB-4476543725B1}"/>
              </a:ext>
            </a:extLst>
          </p:cNvPr>
          <p:cNvSpPr txBox="1"/>
          <p:nvPr/>
        </p:nvSpPr>
        <p:spPr>
          <a:xfrm>
            <a:off x="1992841" y="645403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E5C3A783-D1A6-47AA-AF39-33A3836159AB}"/>
              </a:ext>
            </a:extLst>
          </p:cNvPr>
          <p:cNvSpPr txBox="1"/>
          <p:nvPr/>
        </p:nvSpPr>
        <p:spPr>
          <a:xfrm rot="16200000">
            <a:off x="2866690" y="5325995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31637EEF-9B2B-4DFE-8A76-A573BF204701}"/>
              </a:ext>
            </a:extLst>
          </p:cNvPr>
          <p:cNvSpPr txBox="1"/>
          <p:nvPr/>
        </p:nvSpPr>
        <p:spPr>
          <a:xfrm>
            <a:off x="5202061" y="645403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482A12FA-55A9-4C79-8286-5A491DA47CE7}"/>
              </a:ext>
            </a:extLst>
          </p:cNvPr>
          <p:cNvSpPr txBox="1"/>
          <p:nvPr/>
        </p:nvSpPr>
        <p:spPr>
          <a:xfrm>
            <a:off x="4127204" y="4519920"/>
            <a:ext cx="260316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233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= indeterminable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CS: 3 knots  (HR: 95%CI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4.3 (1.38: 0.85-2.23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percentile = 7.4 (ref.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10.9 (1.05: 0.72-1.53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295FDA79-F812-468B-A3DE-86BBCEC5347C}"/>
              </a:ext>
            </a:extLst>
          </p:cNvPr>
          <p:cNvSpPr txBox="1"/>
          <p:nvPr/>
        </p:nvSpPr>
        <p:spPr>
          <a:xfrm>
            <a:off x="643519" y="2393197"/>
            <a:ext cx="269121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144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= indeterminable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CS: 3 knots (HR: 95%CI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3.3 (1.13: 0.73-1.74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percentile = 5.7 (ref.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8.7 (1.06: 0.68-1.65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46C93735-4F6D-4F97-9131-70C008CEB21D}"/>
              </a:ext>
            </a:extLst>
          </p:cNvPr>
          <p:cNvSpPr txBox="1"/>
          <p:nvPr/>
        </p:nvSpPr>
        <p:spPr>
          <a:xfrm rot="16200000">
            <a:off x="-342530" y="3074285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0BB619CD-5546-41D4-A8B6-D2A17016F037}"/>
              </a:ext>
            </a:extLst>
          </p:cNvPr>
          <p:cNvSpPr txBox="1"/>
          <p:nvPr/>
        </p:nvSpPr>
        <p:spPr>
          <a:xfrm>
            <a:off x="1992841" y="420232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C8E86210-65DC-4F48-AFB6-FEE5E5726405}"/>
              </a:ext>
            </a:extLst>
          </p:cNvPr>
          <p:cNvSpPr txBox="1"/>
          <p:nvPr/>
        </p:nvSpPr>
        <p:spPr>
          <a:xfrm rot="16200000">
            <a:off x="2866690" y="3074285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20ADD537-801D-4BB7-945A-40942AD5A1F9}"/>
              </a:ext>
            </a:extLst>
          </p:cNvPr>
          <p:cNvSpPr txBox="1"/>
          <p:nvPr/>
        </p:nvSpPr>
        <p:spPr>
          <a:xfrm>
            <a:off x="5202061" y="420232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047D4421-5C6A-4E0F-9953-761C206FBDB0}"/>
              </a:ext>
            </a:extLst>
          </p:cNvPr>
          <p:cNvSpPr txBox="1"/>
          <p:nvPr/>
        </p:nvSpPr>
        <p:spPr>
          <a:xfrm>
            <a:off x="3951934" y="2404325"/>
            <a:ext cx="269121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144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= indeterminable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CS: 3 knots (HR: 95%CI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3.3 (1.17: 0.75-1.82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percentile = 5.7 (ref.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8.7 (0.98: 0.62-1.54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B2A086F9-CE4B-4D17-A65F-591032ADA1D4}"/>
              </a:ext>
            </a:extLst>
          </p:cNvPr>
          <p:cNvSpPr txBox="1"/>
          <p:nvPr/>
        </p:nvSpPr>
        <p:spPr>
          <a:xfrm>
            <a:off x="647232" y="287336"/>
            <a:ext cx="269121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044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= indeterminable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3.3 (0.94: 0.72-1.21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percentile = 5.7 (ref.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8.7 (1.09: 0.78-1.51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51090A49-4C49-4BD4-B9C4-FA3C0EE01AFC}"/>
              </a:ext>
            </a:extLst>
          </p:cNvPr>
          <p:cNvSpPr txBox="1"/>
          <p:nvPr/>
        </p:nvSpPr>
        <p:spPr>
          <a:xfrm rot="16200000">
            <a:off x="-342530" y="925445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81C697B5-5A63-4D5C-96DC-51DCDF575F96}"/>
              </a:ext>
            </a:extLst>
          </p:cNvPr>
          <p:cNvSpPr txBox="1"/>
          <p:nvPr/>
        </p:nvSpPr>
        <p:spPr>
          <a:xfrm>
            <a:off x="1992841" y="205348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105E473A-B845-4690-AA02-F5971D3EA690}"/>
              </a:ext>
            </a:extLst>
          </p:cNvPr>
          <p:cNvSpPr txBox="1"/>
          <p:nvPr/>
        </p:nvSpPr>
        <p:spPr>
          <a:xfrm rot="16200000">
            <a:off x="2866690" y="925445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75CA1EC7-44C7-4FF6-9DC1-9968E19BF9E7}"/>
              </a:ext>
            </a:extLst>
          </p:cNvPr>
          <p:cNvSpPr txBox="1"/>
          <p:nvPr/>
        </p:nvSpPr>
        <p:spPr>
          <a:xfrm>
            <a:off x="5202061" y="2053484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F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0C81CFAB-DB6B-4A21-B01C-C6C7412ADFC3}"/>
              </a:ext>
            </a:extLst>
          </p:cNvPr>
          <p:cNvSpPr txBox="1"/>
          <p:nvPr/>
        </p:nvSpPr>
        <p:spPr>
          <a:xfrm>
            <a:off x="3879448" y="319863"/>
            <a:ext cx="275733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047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= indeterminable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3.3 (1.00: 0.76-1.32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th</a:t>
            </a:r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 percentile = 5.7 (ref.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8.7 (1.00: 0.71-1.40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704850" y="5114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/>
          <p:cNvSpPr txBox="1"/>
          <p:nvPr/>
        </p:nvSpPr>
        <p:spPr>
          <a:xfrm>
            <a:off x="3993868" y="5678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26"/>
          <p:cNvSpPr txBox="1"/>
          <p:nvPr/>
        </p:nvSpPr>
        <p:spPr>
          <a:xfrm>
            <a:off x="0" y="8723964"/>
            <a:ext cx="6858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1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Dose-response relationships of FMI with incident disability and mortality risks, excluding disabilities or deaths that occurred during the first year of follow-up 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F66FDD1-38C4-4C41-8CDD-B1C9287E5928}"/>
              </a:ext>
            </a:extLst>
          </p:cNvPr>
          <p:cNvSpPr txBox="1"/>
          <p:nvPr/>
        </p:nvSpPr>
        <p:spPr>
          <a:xfrm>
            <a:off x="0" y="0"/>
            <a:ext cx="10287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e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03D6331C-010B-4301-B5A4-50F6B8ED5345}"/>
              </a:ext>
            </a:extLst>
          </p:cNvPr>
          <p:cNvSpPr txBox="1"/>
          <p:nvPr/>
        </p:nvSpPr>
        <p:spPr>
          <a:xfrm>
            <a:off x="708660" y="220379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FAE4DD2A-D64A-4D19-89B3-77D9C2248B6D}"/>
              </a:ext>
            </a:extLst>
          </p:cNvPr>
          <p:cNvSpPr txBox="1"/>
          <p:nvPr/>
        </p:nvSpPr>
        <p:spPr>
          <a:xfrm>
            <a:off x="3997678" y="220943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C8155764-E544-4939-B205-5BD01424B661}"/>
              </a:ext>
            </a:extLst>
          </p:cNvPr>
          <p:cNvSpPr txBox="1"/>
          <p:nvPr/>
        </p:nvSpPr>
        <p:spPr>
          <a:xfrm>
            <a:off x="15240" y="4347210"/>
            <a:ext cx="10287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Wome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5C058EE1-9BBA-4DE6-8723-94ACDB0DCF75}"/>
              </a:ext>
            </a:extLst>
          </p:cNvPr>
          <p:cNvSpPr txBox="1"/>
          <p:nvPr/>
        </p:nvSpPr>
        <p:spPr>
          <a:xfrm>
            <a:off x="708660" y="429548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7BC9DF35-8B39-4895-B716-1EDFAA7FAD89}"/>
              </a:ext>
            </a:extLst>
          </p:cNvPr>
          <p:cNvSpPr txBox="1"/>
          <p:nvPr/>
        </p:nvSpPr>
        <p:spPr>
          <a:xfrm>
            <a:off x="3997678" y="430112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1EBABE77-10C9-41FE-93EC-DF11EB866820}"/>
              </a:ext>
            </a:extLst>
          </p:cNvPr>
          <p:cNvSpPr txBox="1"/>
          <p:nvPr/>
        </p:nvSpPr>
        <p:spPr>
          <a:xfrm>
            <a:off x="712470" y="659672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2DE9FB2B-8A6F-4D7D-BDDE-B109B99A8EB2}"/>
              </a:ext>
            </a:extLst>
          </p:cNvPr>
          <p:cNvSpPr txBox="1"/>
          <p:nvPr/>
        </p:nvSpPr>
        <p:spPr>
          <a:xfrm>
            <a:off x="4001488" y="660236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>
                <a:latin typeface="Arial" panose="020B0604020202020204" pitchFamily="34" charset="0"/>
                <a:cs typeface="Arial" panose="020B0604020202020204" pitchFamily="34" charset="0"/>
              </a:rPr>
              <a:t>h.</a:t>
            </a: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orta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055416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70</TotalTime>
  <Words>650</Words>
  <Application>Microsoft Office PowerPoint</Application>
  <PresentationFormat>画面に合わせる (4:3)</PresentationFormat>
  <Paragraphs>8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toshi Seino</dc:creator>
  <cp:lastModifiedBy>Seino Satoshi</cp:lastModifiedBy>
  <cp:revision>347</cp:revision>
  <cp:lastPrinted>2019-04-05T09:48:00Z</cp:lastPrinted>
  <dcterms:created xsi:type="dcterms:W3CDTF">2019-01-07T07:45:10Z</dcterms:created>
  <dcterms:modified xsi:type="dcterms:W3CDTF">2022-02-10T10:02:32Z</dcterms:modified>
</cp:coreProperties>
</file>